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813786-02EB-4D6B-8263-BF9975F1B0B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F227ED-E188-467D-A88A-4054BB5D71B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2D71A0-CA73-4859-B184-CA92A74C88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BB280-3F74-44D4-BC71-A2EF7E8F81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A930A2-E13A-4F1E-9199-0B471C0119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2DA6A6-09CE-49EB-92F5-A794828218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E768C-64B7-4EF6-A780-796B45236A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A70BB-04B1-45AE-8D14-6650ACD245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23566-A750-4E3C-81B0-E41CFB52B8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403A1C-D322-4945-87BD-A9AECDC2D8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A4EAE0-5DFC-47FB-A8E2-046BD17D53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E9ADC1-792B-4306-A36C-596F7EF66D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D2FACA-5659-4F2B-825D-D492358BF0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B1EFC-A0A2-4ED6-A948-6FA27D8556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A4E5CF-F0A9-42B5-9D5D-D8C122F5392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5"/>
          <p:cNvSpPr/>
          <p:nvPr/>
        </p:nvSpPr>
        <p:spPr>
          <a:xfrm>
            <a:off x="34200" y="7632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7" descr=""/>
          <p:cNvPicPr/>
          <p:nvPr/>
        </p:nvPicPr>
        <p:blipFill>
          <a:blip r:embed="rId1"/>
          <a:srcRect l="-1185" t="0" r="0" b="64249"/>
          <a:stretch/>
        </p:blipFill>
        <p:spPr>
          <a:xfrm>
            <a:off x="152280" y="457200"/>
            <a:ext cx="6477120" cy="6553080"/>
          </a:xfrm>
          <a:prstGeom prst="rect">
            <a:avLst/>
          </a:prstGeom>
          <a:ln w="0">
            <a:noFill/>
          </a:ln>
        </p:spPr>
      </p:pic>
      <p:sp>
        <p:nvSpPr>
          <p:cNvPr id="50" name="TextBox 14"/>
          <p:cNvSpPr/>
          <p:nvPr/>
        </p:nvSpPr>
        <p:spPr>
          <a:xfrm>
            <a:off x="237240" y="7238880"/>
            <a:ext cx="615600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ignment of conserved N-terminus of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us308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rthologs.  Dmel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Drosophi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elanogaste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Agam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Anopheles gambi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Mmus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us musculu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Hsap,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Homo sapien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Drer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Danio rerio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Atha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Arabidopsis thalian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Cele,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Caenorhabditis elegan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  Conserved amino acids are indicated below eac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ignment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 Box 5"/>
          <p:cNvSpPr/>
          <p:nvPr/>
        </p:nvSpPr>
        <p:spPr>
          <a:xfrm>
            <a:off x="54360" y="76320"/>
            <a:ext cx="367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3 (continued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7" descr=""/>
          <p:cNvPicPr/>
          <p:nvPr/>
        </p:nvPicPr>
        <p:blipFill>
          <a:blip r:embed="rId1"/>
          <a:srcRect l="-1185" t="36583" r="-2375" b="28081"/>
          <a:stretch/>
        </p:blipFill>
        <p:spPr>
          <a:xfrm>
            <a:off x="152280" y="609480"/>
            <a:ext cx="6629400" cy="6477120"/>
          </a:xfrm>
          <a:prstGeom prst="rect">
            <a:avLst/>
          </a:prstGeom>
          <a:ln w="0">
            <a:noFill/>
          </a:ln>
        </p:spPr>
      </p:pic>
      <p:pic>
        <p:nvPicPr>
          <p:cNvPr id="53" name="Right Arrow 4" descr=""/>
          <p:cNvPicPr/>
          <p:nvPr/>
        </p:nvPicPr>
        <p:blipFill>
          <a:blip r:embed="rId2"/>
          <a:stretch/>
        </p:blipFill>
        <p:spPr>
          <a:xfrm>
            <a:off x="3151080" y="1762200"/>
            <a:ext cx="208080" cy="279360"/>
          </a:xfrm>
          <a:prstGeom prst="rect">
            <a:avLst/>
          </a:prstGeom>
          <a:ln w="0">
            <a:noFill/>
          </a:ln>
        </p:spPr>
      </p:pic>
      <p:sp>
        <p:nvSpPr>
          <p:cNvPr id="54" name="TextBox 14"/>
          <p:cNvSpPr/>
          <p:nvPr/>
        </p:nvSpPr>
        <p:spPr>
          <a:xfrm>
            <a:off x="241200" y="7238880"/>
            <a:ext cx="646884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ignment of conserved N-terminus of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us308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rthologs.  Dmel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Drosophi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elanogaste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Agam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Anopheles gambi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Mmus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us musculu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Hsap,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Homo sapien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Drer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Danio rerio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Atha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Arabidopsis thalian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Cele,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Caenorhabditis elegan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  Conserved amino acids are indicated below eac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ignment.   The red arrow corresponds to the G621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 substitution in the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329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lele, the blue arrow corresponds to the P781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 substitution in the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D5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lel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Right Arrow 9" descr=""/>
          <p:cNvPicPr/>
          <p:nvPr/>
        </p:nvPicPr>
        <p:blipFill>
          <a:blip r:embed="rId3"/>
          <a:stretch/>
        </p:blipFill>
        <p:spPr>
          <a:xfrm>
            <a:off x="1176480" y="5645160"/>
            <a:ext cx="207720" cy="285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 Box 5"/>
          <p:cNvSpPr/>
          <p:nvPr/>
        </p:nvSpPr>
        <p:spPr>
          <a:xfrm>
            <a:off x="54360" y="76320"/>
            <a:ext cx="367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3 (continued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7" descr=""/>
          <p:cNvPicPr/>
          <p:nvPr/>
        </p:nvPicPr>
        <p:blipFill>
          <a:blip r:embed="rId1"/>
          <a:srcRect l="-1185" t="71921" r="-2375" b="0"/>
          <a:stretch/>
        </p:blipFill>
        <p:spPr>
          <a:xfrm>
            <a:off x="152280" y="533520"/>
            <a:ext cx="6629400" cy="5146560"/>
          </a:xfrm>
          <a:prstGeom prst="rect">
            <a:avLst/>
          </a:prstGeom>
          <a:ln w="0">
            <a:noFill/>
          </a:ln>
        </p:spPr>
      </p:pic>
      <p:sp>
        <p:nvSpPr>
          <p:cNvPr id="58" name="TextBox 14"/>
          <p:cNvSpPr/>
          <p:nvPr/>
        </p:nvSpPr>
        <p:spPr>
          <a:xfrm>
            <a:off x="237240" y="7238880"/>
            <a:ext cx="615600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ignment of conserved N-terminus of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us308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rthologs.  Dmel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Drosophi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elanogaste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Agam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Anopheles gambi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Mmus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us musculu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Hsap,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Homo sapien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Drer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Danio rerio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Atha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Arabidopsis thalian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; Cele,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Caenorhabditis elegan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  Conserved amino acids are indicated below eac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ignment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05:35:51Z</dcterms:created>
  <dc:creator>Mitch McVey</dc:creator>
  <dc:description/>
  <dc:language>en-US</dc:language>
  <cp:lastModifiedBy>Mitch McVey</cp:lastModifiedBy>
  <dcterms:modified xsi:type="dcterms:W3CDTF">2010-05-09T18:00:07Z</dcterms:modified>
  <cp:revision>2</cp:revision>
  <dc:subject/>
  <dc:title>Slide 1</dc:title>
</cp:coreProperties>
</file>